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50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5748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301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811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975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69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315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590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2820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304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69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0071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56D29-7BF3-42F8-9D42-1AEC43C14401}" type="datetimeFigureOut">
              <a:rPr lang="en-GB" smtClean="0"/>
              <a:t>06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51DB4-CB5C-4F53-9322-83402B5E342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311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668995"/>
              </p:ext>
            </p:extLst>
          </p:nvPr>
        </p:nvGraphicFramePr>
        <p:xfrm>
          <a:off x="3018344" y="1816484"/>
          <a:ext cx="6127087" cy="1046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312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888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98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452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dirty="0"/>
                        <a:t>Cell li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dirty="0"/>
                        <a:t>Se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dirty="0"/>
                        <a:t>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dirty="0"/>
                        <a:t>Sequence variation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SU-DIPG-IV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/>
                        <a:t>Fem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/>
                        <a:t>2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HIST1H3B p.Lys28Met (c.83A&gt;T) (H3.1K27M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4150"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/>
                        <a:t>VUMC-DIPG-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/>
                        <a:t>Fem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/>
                        <a:t>3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H3F3A p.Lys28Met (c.83A&gt;T) (H3.3K27M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" name="CuadroTexto 3"/>
          <p:cNvSpPr txBox="1"/>
          <p:nvPr/>
        </p:nvSpPr>
        <p:spPr>
          <a:xfrm>
            <a:off x="306184" y="157972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Supplementary Figure 1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0760529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1</Words>
  <Application>Microsoft Office PowerPoint</Application>
  <PresentationFormat>Panorámica</PresentationFormat>
  <Paragraphs>1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vid Roig Carles</dc:creator>
  <cp:lastModifiedBy>David Roig Carles</cp:lastModifiedBy>
  <cp:revision>4</cp:revision>
  <dcterms:created xsi:type="dcterms:W3CDTF">2021-04-26T20:53:46Z</dcterms:created>
  <dcterms:modified xsi:type="dcterms:W3CDTF">2021-05-06T11:08:53Z</dcterms:modified>
</cp:coreProperties>
</file>